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50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7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115D20-3DF0-4C5D-8E94-03DA315975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F378D0-8C3A-416B-BA43-6498A2B1CA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E702C2-5582-4516-B0EF-7378E9545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D72F3F-1E5C-4385-ACDB-4C3469911E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F98584-50F3-459D-8463-F125D7E15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0908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76798F-F0A4-40F8-8E87-1771719882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1AF213-F629-4296-8A91-8028112040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222CCF-2DAD-4327-8B90-FEBEB91C0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8A7E16-7740-4B65-A150-E99B25578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73B30F-4F0A-41F1-92D2-48A13AD905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7747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18FD95-0114-47BB-B94E-1F529538EA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5AB7A1-DB70-4549-913E-6C6E8BB151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C491AA-F4F5-42D6-A8E2-166C6745F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8061D7-4D11-4587-942E-B9B82838C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5B1160-C590-4F7A-ACFA-C887BD6A2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236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FCD77E-9EA1-478D-B737-07EAA46636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6F51E2-34C4-4334-A5F8-78D6240435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934350-7B22-4AF1-AE5C-CE2159E9A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44D59E-23D5-4867-858B-FD0BA3D55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858EFA-F367-4F5E-9D16-E3481C7E1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48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EAD77C-30D7-4C75-8743-D2D97F864C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0147AA-780F-4578-8B67-1E3253412E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80833B-C753-44CA-ADE8-B29CCA5DD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58BFC2-E9FA-47B4-9CEF-CC5B7B744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0DEE52-7884-41FD-9F7C-4452F77DB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6452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D882F-E2E3-4CD3-90C1-90E68A8498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770E76-E3FA-46D4-9210-EEAFEDF925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139C12-E917-446B-9D1D-63CB4725F9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558BAF-72C8-40C5-97AE-8CD9186C3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E40085-5417-4ADB-96BE-33BB7A354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A2FB6B-779C-4C42-9487-2588A7124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9709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BA78CE-E665-4A69-BAB0-A9A260B53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665B37-5734-44F3-B642-DCC9F74209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37BB75-5DA2-4FFF-880E-E5529F2E0F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101FEA-1C39-4819-B3D0-99A766E4B3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1E6432E-222F-4E78-8B65-9AF2DCA30B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5E879B-1BC3-4C83-B44A-723FF5259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AD20D2-C026-4679-AFD7-3B209CE91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D78B975-1D8B-46C0-8BE3-88C716114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3868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D6D474-7017-48F3-9B8E-9722DC23B0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8D77E23-A969-4F6E-9B3C-D9EEDC5D1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7A3C3D-2A6E-4D81-816B-3EB62BC74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D42335-A9C7-47EA-92C4-EC38725B1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8293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7CE352-D55C-4757-BAF7-C52C85E24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8EEE56-8540-46C0-9834-ADE9D775A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187C7B-7521-43DA-BDD7-0CF69CF49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9198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942366-9DB6-483E-AC7C-983DC98B5E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1670A8-1E5D-444F-90C7-C88F379D0B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E29101-00A8-48C9-A614-96BA6BF364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59524A-F4BF-4773-A60A-D8FE413919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D81DA2-21FE-42FD-BFA4-BAC419D18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4B43D7-EA37-49FC-BD98-37385786C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915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59E129-0DB8-45C7-8280-FD1C66268B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CC1BBB-2D01-4A0D-8BE6-254E436497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412C87-6605-4AEC-B9AE-53091996C3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C90281-D858-4502-B426-56C80A302C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D02430-91FB-401D-B07A-D7F713B0F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17F7E4-C5FA-4EDB-9495-3310919AA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7520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80B513-410E-45F8-B422-9E488DAF86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C1D4F3-BB00-4892-A0B7-72ABCB6DDB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C72878-9ED0-46A6-951F-B8EFA197EA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710FA-D2C4-45EB-84DA-EF05BB96C6C5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392DD-5E2D-47EA-8579-EF36C4267D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D6DB3C-011F-4A81-AC0D-98D964DE0A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319653-6FFE-4AC1-A953-D3BFA08FEE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7797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3C563C-B023-4453-88AB-F14A986AD35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A11963-E1F9-40C1-8670-139E5A41AB9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5BF1AC5-BDCB-4417-BF7E-5F6C4C6C16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130" y="11389"/>
            <a:ext cx="10052670" cy="603160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86500C7-2125-411A-B3BF-A0662CE35F4D}"/>
              </a:ext>
            </a:extLst>
          </p:cNvPr>
          <p:cNvSpPr txBox="1"/>
          <p:nvPr/>
        </p:nvSpPr>
        <p:spPr>
          <a:xfrm>
            <a:off x="1235765" y="6173976"/>
            <a:ext cx="100526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5:</a:t>
            </a:r>
            <a:r>
              <a:rPr lang="en-US" sz="1400" dirty="0"/>
              <a:t> Pearson’s correlation of </a:t>
            </a:r>
            <a:r>
              <a:rPr lang="en-US" sz="1400" dirty="0" err="1"/>
              <a:t>RNAseq</a:t>
            </a:r>
            <a:r>
              <a:rPr lang="en-US" sz="1400" dirty="0"/>
              <a:t> reads in each sample that map to fungal transcripts versus lesion size in (A) </a:t>
            </a:r>
            <a:r>
              <a:rPr lang="en-US" sz="1400" i="1" dirty="0"/>
              <a:t>S. </a:t>
            </a:r>
            <a:r>
              <a:rPr lang="en-US" sz="1400" i="1" dirty="0" err="1"/>
              <a:t>sclerotiorum</a:t>
            </a:r>
            <a:r>
              <a:rPr lang="en-US" sz="1400" i="1" dirty="0"/>
              <a:t> </a:t>
            </a:r>
            <a:r>
              <a:rPr lang="en-US" sz="1400" dirty="0"/>
              <a:t>and (B) </a:t>
            </a:r>
            <a:r>
              <a:rPr lang="en-US" sz="1400" i="1" dirty="0"/>
              <a:t>B. cinerea </a:t>
            </a:r>
            <a:r>
              <a:rPr lang="en-US" sz="1400" dirty="0"/>
              <a:t>inoculated samples. 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670289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y Pink</dc:creator>
  <cp:lastModifiedBy>Katherine Denby</cp:lastModifiedBy>
  <cp:revision>6</cp:revision>
  <dcterms:created xsi:type="dcterms:W3CDTF">2021-09-23T15:19:13Z</dcterms:created>
  <dcterms:modified xsi:type="dcterms:W3CDTF">2022-02-20T15:37:43Z</dcterms:modified>
</cp:coreProperties>
</file>